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57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-557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73FF51-A23A-4E2C-9F72-9FC02A74E9D4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27F7D1-8F2F-474B-8672-093E02E220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2770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he effects of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 on PI3K, p-AKT, AKT protein in the DN rat model based on a WB assay. DN group, high-fat and high-glucose diet-fed STZ-induced DN rats. DN + CL group, DN rats were given by gavage low dose (0.5 mg/kg)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. DN + CH group, DN rats were given by gavage high dose (1.5 mg/kg/d)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. DN + INH group, DN rats were </a:t>
            </a:r>
            <a:r>
              <a:rPr lang="en-US" altLang="zh-CN" dirty="0" err="1" smtClean="0"/>
              <a:t>intraperitoneally</a:t>
            </a:r>
            <a:r>
              <a:rPr lang="en-US" altLang="zh-CN" dirty="0" smtClean="0"/>
              <a:t> injected with LY294002 (1.2 mg/kg/d). Following the once per day administration of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 or LY294002 for 4 weeks for the intervention, rats were sacrificed and the PI3K, p-AKT, AKT protein levels determined by a WB assay of renal tissues. The results were quantified by normalizing to GAPDH. *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5, **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1 compared to NC, </a:t>
            </a:r>
            <a:r>
              <a:rPr lang="en-US" altLang="zh-CN" baseline="30000" dirty="0" smtClean="0"/>
              <a:t>#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5, </a:t>
            </a:r>
            <a:r>
              <a:rPr lang="en-US" altLang="zh-CN" baseline="30000" dirty="0" smtClean="0"/>
              <a:t>##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1 compared to DN. DN, diabetic nephropathy. We used the one-way analysis of variance (ANOVA), followed by Turkey's multiple comparison test to analyze the differences. The columns on the right are the original gels of PI3K, P-AKT, AKT, GAPDH, respectively.</a:t>
            </a:r>
            <a:endParaRPr lang="zh-CN" altLang="zh-CN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27F7D1-8F2F-474B-8672-093E02E2208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2113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he effects of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 on PI3K, p-AKT, AKT protein in the DN rat model based on a WB assay. DN group, high-fat and high-glucose diet-fed STZ-induced DN rats. DN + CL group, DN rats were given by gavage low dose (0.5 mg/kg)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. DN + CH group, DN rats were given by gavage high dose (1.5 mg/kg/d)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. DN + INH group, DN rats were </a:t>
            </a:r>
            <a:r>
              <a:rPr lang="en-US" altLang="zh-CN" dirty="0" err="1" smtClean="0"/>
              <a:t>intraperitoneally</a:t>
            </a:r>
            <a:r>
              <a:rPr lang="en-US" altLang="zh-CN" dirty="0" smtClean="0"/>
              <a:t> injected with LY294002 (1.2 mg/kg/d). Following the once per day administration of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 or LY294002 for 4 weeks for the intervention, rats were sacrificed and the PI3K, p-AKT, AKT protein levels determined by a WB assay of renal tissues. The results were quantified by normalizing to GAPDH. *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5, **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1 compared to NC, </a:t>
            </a:r>
            <a:r>
              <a:rPr lang="en-US" altLang="zh-CN" baseline="30000" dirty="0" smtClean="0"/>
              <a:t>#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5, </a:t>
            </a:r>
            <a:r>
              <a:rPr lang="en-US" altLang="zh-CN" baseline="30000" dirty="0" smtClean="0"/>
              <a:t>##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1 compared to DN. DN, diabetic nephropathy. We used the one-way analysis of variance (ANOVA), followed by Turkey's multiple comparison test to analyze the differences.</a:t>
            </a:r>
            <a:endParaRPr lang="zh-CN" altLang="zh-CN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27F7D1-8F2F-474B-8672-093E02E2208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9052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The effects of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 on LC3II protein in the DN rat model based on a WB assay. DN group, high-fat and high-glucose diet-fed STZ-induced DN rats. DN + CL group, DN rats were given by gavage low dose (0.5 mg/kg)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. DN + CH group, DN rats were given by gavage high dose (1.5 mg/kg/d)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. DN + INH group, DN rats were </a:t>
            </a:r>
            <a:r>
              <a:rPr lang="en-US" altLang="zh-CN" dirty="0" err="1" smtClean="0"/>
              <a:t>intraperitoneally</a:t>
            </a:r>
            <a:r>
              <a:rPr lang="en-US" altLang="zh-CN" dirty="0" smtClean="0"/>
              <a:t> injected with LY294002 (1.2 mg/kg/d). Following the once per day administration of </a:t>
            </a:r>
            <a:r>
              <a:rPr lang="en-US" altLang="zh-CN" dirty="0" err="1" smtClean="0"/>
              <a:t>Celastrol</a:t>
            </a:r>
            <a:r>
              <a:rPr lang="en-US" altLang="zh-CN" dirty="0" smtClean="0"/>
              <a:t> or LY294002 for 4 weeks for the intervention, rats were sacrificed and the LC3II protein levels determined by a WB assay of renal tissues. The results were quantified by normalizing to β-actin. *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5, **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1 compared to NC, </a:t>
            </a:r>
            <a:r>
              <a:rPr lang="en-US" altLang="zh-CN" baseline="30000" dirty="0" smtClean="0"/>
              <a:t>#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5, </a:t>
            </a:r>
            <a:r>
              <a:rPr lang="en-US" altLang="zh-CN" baseline="30000" dirty="0" smtClean="0"/>
              <a:t>##</a:t>
            </a:r>
            <a:r>
              <a:rPr lang="en-US" altLang="zh-CN" i="1" dirty="0" smtClean="0"/>
              <a:t> p &lt;</a:t>
            </a:r>
            <a:r>
              <a:rPr lang="en-US" altLang="zh-CN" dirty="0" smtClean="0"/>
              <a:t>0.01 compared to DN. DN, diabetic nephropathy. We used the one-way analysis of variance (ANOVA), followed by Turkey's multiple comparison test to analyze the differences. The columns on the right are the original gels of LC3II and β-actin.  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27F7D1-8F2F-474B-8672-093E02E2208E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8271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A2D46-0AE0-414F-B952-E1E5FFCCE3A7}" type="datetimeFigureOut">
              <a:rPr lang="zh-CN" altLang="en-US" smtClean="0"/>
              <a:t>2020/6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0E63B6-6446-41A8-BA45-F9B4C13726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3030965" y="3380291"/>
            <a:ext cx="2880000" cy="50336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3031115" y="2583315"/>
            <a:ext cx="2880000" cy="421757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3030965" y="1750423"/>
            <a:ext cx="2880000" cy="46736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>
            <a:grayscl/>
          </a:blip>
          <a:stretch>
            <a:fillRect/>
          </a:stretch>
        </p:blipFill>
        <p:spPr>
          <a:xfrm>
            <a:off x="3030965" y="881796"/>
            <a:ext cx="2880000" cy="5006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083711" y="984816"/>
            <a:ext cx="7604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PI3K</a:t>
            </a:r>
            <a:endParaRPr lang="zh-CN" altLang="en-US" sz="1600" b="1" dirty="0"/>
          </a:p>
        </p:txBody>
      </p:sp>
      <p:sp>
        <p:nvSpPr>
          <p:cNvPr id="12" name="文本框 11"/>
          <p:cNvSpPr txBox="1"/>
          <p:nvPr/>
        </p:nvSpPr>
        <p:spPr>
          <a:xfrm>
            <a:off x="2082207" y="1791324"/>
            <a:ext cx="7604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P-Akt</a:t>
            </a:r>
            <a:endParaRPr lang="zh-CN" altLang="en-US" sz="1600" b="1" dirty="0"/>
          </a:p>
        </p:txBody>
      </p:sp>
      <p:sp>
        <p:nvSpPr>
          <p:cNvPr id="13" name="文本框 12"/>
          <p:cNvSpPr txBox="1"/>
          <p:nvPr/>
        </p:nvSpPr>
        <p:spPr>
          <a:xfrm>
            <a:off x="2083404" y="3462394"/>
            <a:ext cx="927792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GAPDH</a:t>
            </a:r>
            <a:endParaRPr lang="zh-CN" altLang="en-US" sz="1600" b="1" dirty="0"/>
          </a:p>
        </p:txBody>
      </p:sp>
      <p:sp>
        <p:nvSpPr>
          <p:cNvPr id="14" name="文本框 13"/>
          <p:cNvSpPr txBox="1"/>
          <p:nvPr/>
        </p:nvSpPr>
        <p:spPr>
          <a:xfrm>
            <a:off x="2081970" y="2624274"/>
            <a:ext cx="7604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Akt</a:t>
            </a:r>
            <a:endParaRPr lang="zh-CN" altLang="en-US" sz="1600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6465" y="3380291"/>
            <a:ext cx="2880000" cy="503363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6615" y="2583315"/>
            <a:ext cx="2880000" cy="421757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6465" y="1750423"/>
            <a:ext cx="2880000" cy="46736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96465" y="881796"/>
            <a:ext cx="2880000" cy="50060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3157855" y="3883660"/>
            <a:ext cx="34016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NC       DN     DN+CL   DN+CH   DN+INH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9796570" y="963503"/>
            <a:ext cx="7604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PI3K</a:t>
            </a:r>
            <a:endParaRPr lang="zh-CN" altLang="en-US" sz="1600" b="1" dirty="0"/>
          </a:p>
        </p:txBody>
      </p:sp>
      <p:sp>
        <p:nvSpPr>
          <p:cNvPr id="21" name="文本框 20"/>
          <p:cNvSpPr txBox="1"/>
          <p:nvPr/>
        </p:nvSpPr>
        <p:spPr>
          <a:xfrm>
            <a:off x="9796570" y="1791324"/>
            <a:ext cx="7604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P-Akt</a:t>
            </a:r>
            <a:endParaRPr lang="zh-CN" altLang="en-US" sz="1600" b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9820658" y="2611188"/>
            <a:ext cx="7604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Akt</a:t>
            </a:r>
            <a:endParaRPr lang="zh-CN" altLang="en-US" sz="1600" b="1" dirty="0"/>
          </a:p>
        </p:txBody>
      </p:sp>
      <p:sp>
        <p:nvSpPr>
          <p:cNvPr id="23" name="文本框 22"/>
          <p:cNvSpPr txBox="1"/>
          <p:nvPr/>
        </p:nvSpPr>
        <p:spPr>
          <a:xfrm>
            <a:off x="9796570" y="3381072"/>
            <a:ext cx="927792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GAPDH</a:t>
            </a:r>
            <a:endParaRPr lang="zh-CN" altLang="en-US" sz="16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1.WB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7951" y="353405"/>
            <a:ext cx="7978140" cy="616966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346036" y="1745673"/>
            <a:ext cx="111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KT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2124364" y="3633891"/>
            <a:ext cx="1006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9051636" y="1597891"/>
            <a:ext cx="1228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I3K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8936182" y="3456769"/>
            <a:ext cx="1228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AKT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PI3K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1035" y="208280"/>
            <a:ext cx="8329295" cy="644144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045527" y="3537527"/>
            <a:ext cx="1228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I3K</a:t>
            </a:r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p-akt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1025" y="146050"/>
            <a:ext cx="8490585" cy="656653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532910" y="3244651"/>
            <a:ext cx="1228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AKT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AKT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895" y="225425"/>
            <a:ext cx="8284210" cy="640651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546763" y="2937164"/>
            <a:ext cx="111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KT</a:t>
            </a:r>
            <a:endParaRPr lang="zh-CN" alt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GAPD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4060" y="196850"/>
            <a:ext cx="8359140" cy="64643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149600" y="3244334"/>
            <a:ext cx="1006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微信图片_202006262208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7785" y="118745"/>
            <a:ext cx="3724275" cy="662114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737456" y="5656655"/>
            <a:ext cx="1006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2737456" y="4100946"/>
            <a:ext cx="111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KT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2737456" y="2459560"/>
            <a:ext cx="1228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AKT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2737456" y="1088517"/>
            <a:ext cx="1228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I3K</a:t>
            </a:r>
            <a:endParaRPr lang="zh-CN" alt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1593215" y="1283335"/>
            <a:ext cx="15405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LC3-II(14kDa)</a:t>
            </a:r>
            <a:endParaRPr lang="zh-CN" altLang="en-US" sz="16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1593215" y="1873885"/>
            <a:ext cx="15405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β-actin(42kDa)</a:t>
            </a:r>
            <a:endParaRPr lang="zh-CN" altLang="en-US" sz="1600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3190" y="1796415"/>
            <a:ext cx="2880000" cy="45513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73190" y="1242060"/>
            <a:ext cx="2880000" cy="420438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3133725" y="1242060"/>
            <a:ext cx="2880000" cy="4212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>
          <a:blip r:embed="rId6">
            <a:grayscl/>
          </a:blip>
          <a:stretch>
            <a:fillRect/>
          </a:stretch>
        </p:blipFill>
        <p:spPr>
          <a:xfrm>
            <a:off x="3133725" y="1795780"/>
            <a:ext cx="2880000" cy="45360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3222625" y="935355"/>
            <a:ext cx="34016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NC       DN     DN+CL   DN+CH   DN+INH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621</Words>
  <Application>Microsoft Office PowerPoint</Application>
  <PresentationFormat>宽屏</PresentationFormat>
  <Paragraphs>30</Paragraphs>
  <Slides>8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Pad</dc:creator>
  <cp:lastModifiedBy>huimin</cp:lastModifiedBy>
  <cp:revision>87</cp:revision>
  <dcterms:created xsi:type="dcterms:W3CDTF">2019-08-07T09:11:00Z</dcterms:created>
  <dcterms:modified xsi:type="dcterms:W3CDTF">2020-06-27T03:2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828</vt:lpwstr>
  </property>
</Properties>
</file>